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19"/>
  </p:handout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3" r:id="rId18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37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FE4A5EBF-B5CE-4B63-895F-5F97628ECA3E}" type="datetimeFigureOut">
              <a:rPr lang="en-US" smtClean="0"/>
              <a:t>5/1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161EE14B-FA36-4DF5-AFDB-801AB211C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502175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E58DF-BE2B-4382-8A73-45446A09D2FB}" type="datetimeFigureOut">
              <a:rPr lang="en-US" smtClean="0"/>
              <a:t>5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BB84-65DF-41B2-8B73-980080F6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859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E58DF-BE2B-4382-8A73-45446A09D2FB}" type="datetimeFigureOut">
              <a:rPr lang="en-US" smtClean="0"/>
              <a:t>5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BB84-65DF-41B2-8B73-980080F6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1178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E58DF-BE2B-4382-8A73-45446A09D2FB}" type="datetimeFigureOut">
              <a:rPr lang="en-US" smtClean="0"/>
              <a:t>5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BB84-65DF-41B2-8B73-980080F6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9658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E58DF-BE2B-4382-8A73-45446A09D2FB}" type="datetimeFigureOut">
              <a:rPr lang="en-US" smtClean="0"/>
              <a:t>5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BB84-65DF-41B2-8B73-980080F6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0533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E58DF-BE2B-4382-8A73-45446A09D2FB}" type="datetimeFigureOut">
              <a:rPr lang="en-US" smtClean="0"/>
              <a:t>5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BB84-65DF-41B2-8B73-980080F6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26416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E58DF-BE2B-4382-8A73-45446A09D2FB}" type="datetimeFigureOut">
              <a:rPr lang="en-US" smtClean="0"/>
              <a:t>5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BB84-65DF-41B2-8B73-980080F6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921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E58DF-BE2B-4382-8A73-45446A09D2FB}" type="datetimeFigureOut">
              <a:rPr lang="en-US" smtClean="0"/>
              <a:t>5/1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BB84-65DF-41B2-8B73-980080F6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1732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E58DF-BE2B-4382-8A73-45446A09D2FB}" type="datetimeFigureOut">
              <a:rPr lang="en-US" smtClean="0"/>
              <a:t>5/1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BB84-65DF-41B2-8B73-980080F6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0875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E58DF-BE2B-4382-8A73-45446A09D2FB}" type="datetimeFigureOut">
              <a:rPr lang="en-US" smtClean="0"/>
              <a:t>5/1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BB84-65DF-41B2-8B73-980080F6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355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E58DF-BE2B-4382-8A73-45446A09D2FB}" type="datetimeFigureOut">
              <a:rPr lang="en-US" smtClean="0"/>
              <a:t>5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BB84-65DF-41B2-8B73-980080F6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6377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FE58DF-BE2B-4382-8A73-45446A09D2FB}" type="datetimeFigureOut">
              <a:rPr lang="en-US" smtClean="0"/>
              <a:t>5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BB84-65DF-41B2-8B73-980080F6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4033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FE58DF-BE2B-4382-8A73-45446A09D2FB}" type="datetimeFigureOut">
              <a:rPr lang="en-US" smtClean="0"/>
              <a:t>5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02BB84-65DF-41B2-8B73-980080F6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847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jpg"/><Relationship Id="rId2" Type="http://schemas.openxmlformats.org/officeDocument/2006/relationships/image" Target="../media/image42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5.jpg"/><Relationship Id="rId4" Type="http://schemas.openxmlformats.org/officeDocument/2006/relationships/image" Target="../media/image44.jp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jpg"/><Relationship Id="rId7" Type="http://schemas.openxmlformats.org/officeDocument/2006/relationships/image" Target="../media/image51.jpg"/><Relationship Id="rId2" Type="http://schemas.openxmlformats.org/officeDocument/2006/relationships/image" Target="../media/image46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jpg"/><Relationship Id="rId5" Type="http://schemas.openxmlformats.org/officeDocument/2006/relationships/image" Target="../media/image49.jpg"/><Relationship Id="rId4" Type="http://schemas.openxmlformats.org/officeDocument/2006/relationships/image" Target="../media/image48.jp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jpg"/><Relationship Id="rId2" Type="http://schemas.openxmlformats.org/officeDocument/2006/relationships/image" Target="../media/image52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5.jpg"/><Relationship Id="rId4" Type="http://schemas.openxmlformats.org/officeDocument/2006/relationships/image" Target="../media/image54.jp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jpg"/><Relationship Id="rId7" Type="http://schemas.openxmlformats.org/officeDocument/2006/relationships/image" Target="../media/image61.jpg"/><Relationship Id="rId2" Type="http://schemas.openxmlformats.org/officeDocument/2006/relationships/image" Target="../media/image56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0.jpg"/><Relationship Id="rId5" Type="http://schemas.openxmlformats.org/officeDocument/2006/relationships/image" Target="../media/image59.jpg"/><Relationship Id="rId4" Type="http://schemas.openxmlformats.org/officeDocument/2006/relationships/image" Target="../media/image58.jp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jpg"/><Relationship Id="rId2" Type="http://schemas.openxmlformats.org/officeDocument/2006/relationships/image" Target="../media/image62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5.jpg"/><Relationship Id="rId4" Type="http://schemas.openxmlformats.org/officeDocument/2006/relationships/image" Target="../media/image64.jp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2.jpg"/><Relationship Id="rId3" Type="http://schemas.openxmlformats.org/officeDocument/2006/relationships/image" Target="../media/image67.jpg"/><Relationship Id="rId7" Type="http://schemas.openxmlformats.org/officeDocument/2006/relationships/image" Target="../media/image71.jpg"/><Relationship Id="rId2" Type="http://schemas.openxmlformats.org/officeDocument/2006/relationships/image" Target="../media/image66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0.jpg"/><Relationship Id="rId5" Type="http://schemas.openxmlformats.org/officeDocument/2006/relationships/image" Target="../media/image69.jpg"/><Relationship Id="rId10" Type="http://schemas.openxmlformats.org/officeDocument/2006/relationships/image" Target="../media/image74.jpg"/><Relationship Id="rId4" Type="http://schemas.openxmlformats.org/officeDocument/2006/relationships/image" Target="../media/image68.jpg"/><Relationship Id="rId9" Type="http://schemas.openxmlformats.org/officeDocument/2006/relationships/image" Target="../media/image73.jp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6.jpg"/><Relationship Id="rId2" Type="http://schemas.openxmlformats.org/officeDocument/2006/relationships/image" Target="../media/image7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9.jpg"/><Relationship Id="rId5" Type="http://schemas.openxmlformats.org/officeDocument/2006/relationships/image" Target="../media/image78.jpg"/><Relationship Id="rId4" Type="http://schemas.openxmlformats.org/officeDocument/2006/relationships/image" Target="../media/image77.jp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1.jpg"/><Relationship Id="rId2" Type="http://schemas.openxmlformats.org/officeDocument/2006/relationships/image" Target="../media/image80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3.jpg"/><Relationship Id="rId4" Type="http://schemas.openxmlformats.org/officeDocument/2006/relationships/image" Target="../media/image82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g"/><Relationship Id="rId7" Type="http://schemas.openxmlformats.org/officeDocument/2006/relationships/image" Target="../media/image21.jpg"/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jpg"/><Relationship Id="rId5" Type="http://schemas.openxmlformats.org/officeDocument/2006/relationships/image" Target="../media/image19.jpg"/><Relationship Id="rId4" Type="http://schemas.openxmlformats.org/officeDocument/2006/relationships/image" Target="../media/image18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g"/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5.jpg"/><Relationship Id="rId4" Type="http://schemas.openxmlformats.org/officeDocument/2006/relationships/image" Target="../media/image24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g"/><Relationship Id="rId7" Type="http://schemas.openxmlformats.org/officeDocument/2006/relationships/image" Target="../media/image31.jpg"/><Relationship Id="rId2" Type="http://schemas.openxmlformats.org/officeDocument/2006/relationships/image" Target="../media/image26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jpg"/><Relationship Id="rId5" Type="http://schemas.openxmlformats.org/officeDocument/2006/relationships/image" Target="../media/image29.jpg"/><Relationship Id="rId4" Type="http://schemas.openxmlformats.org/officeDocument/2006/relationships/image" Target="../media/image28.jp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jpg"/><Relationship Id="rId2" Type="http://schemas.openxmlformats.org/officeDocument/2006/relationships/image" Target="../media/image32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5.jpg"/><Relationship Id="rId4" Type="http://schemas.openxmlformats.org/officeDocument/2006/relationships/image" Target="../media/image34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jpg"/><Relationship Id="rId7" Type="http://schemas.openxmlformats.org/officeDocument/2006/relationships/image" Target="../media/image41.jpg"/><Relationship Id="rId2" Type="http://schemas.openxmlformats.org/officeDocument/2006/relationships/image" Target="../media/image36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jpg"/><Relationship Id="rId5" Type="http://schemas.openxmlformats.org/officeDocument/2006/relationships/image" Target="../media/image39.jpg"/><Relationship Id="rId4" Type="http://schemas.openxmlformats.org/officeDocument/2006/relationships/image" Target="../media/image3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5656" y="2152737"/>
            <a:ext cx="7886700" cy="1325563"/>
          </a:xfrm>
        </p:spPr>
        <p:txBody>
          <a:bodyPr>
            <a:normAutofit/>
          </a:bodyPr>
          <a:lstStyle/>
          <a:p>
            <a:r>
              <a:rPr lang="en-US" sz="3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Information </a:t>
            </a:r>
            <a:r>
              <a:rPr lang="en-US" sz="3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: </a:t>
            </a:r>
            <a:r>
              <a:rPr lang="en-US" sz="3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- o</a:t>
            </a:r>
            <a:endParaRPr lang="en-US" sz="3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02631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3429001"/>
            <a:ext cx="2933700" cy="2200275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3429001"/>
            <a:ext cx="2933700" cy="2200275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1028701"/>
            <a:ext cx="2933700" cy="2200275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1028701"/>
            <a:ext cx="2933700" cy="220027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6268315"/>
            <a:ext cx="73129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i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104900" y="3144323"/>
            <a:ext cx="394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262942" y="5680855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53061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3600" y="3429001"/>
            <a:ext cx="2933700" cy="220027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1800" y="3429001"/>
            <a:ext cx="2933700" cy="220027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429001"/>
            <a:ext cx="2933700" cy="220027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28701"/>
            <a:ext cx="2933700" cy="2200275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1800" y="1028701"/>
            <a:ext cx="2933700" cy="2200275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3600" y="1028701"/>
            <a:ext cx="2933700" cy="2200275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0" y="6268315"/>
            <a:ext cx="73129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j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-76200" y="3059668"/>
            <a:ext cx="394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262942" y="5680855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42313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3429001"/>
            <a:ext cx="2933700" cy="2200275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3429001"/>
            <a:ext cx="2933700" cy="2200275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1028701"/>
            <a:ext cx="2933700" cy="2200275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1028701"/>
            <a:ext cx="2933700" cy="220027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6268315"/>
            <a:ext cx="82266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k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976940" y="3059669"/>
            <a:ext cx="394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262942" y="5680855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88928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3600" y="3429001"/>
            <a:ext cx="2933700" cy="220027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1800" y="3429001"/>
            <a:ext cx="2933700" cy="220027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429001"/>
            <a:ext cx="2933700" cy="220027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1827" y="1028701"/>
            <a:ext cx="2933700" cy="220027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1800" y="1028701"/>
            <a:ext cx="2933700" cy="220027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28701"/>
            <a:ext cx="2933700" cy="2200275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0" y="6268315"/>
            <a:ext cx="73129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l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-76200" y="3059668"/>
            <a:ext cx="394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262942" y="5680855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07395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1028701"/>
            <a:ext cx="2933700" cy="2200275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3429001"/>
            <a:ext cx="2933700" cy="2200275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1028701"/>
            <a:ext cx="2933700" cy="2200275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3429001"/>
            <a:ext cx="2933700" cy="220027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6268315"/>
            <a:ext cx="93647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m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104900" y="3144323"/>
            <a:ext cx="394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262942" y="5680855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96428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96460" y="1"/>
            <a:ext cx="2933700" cy="2200275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1800" y="1"/>
            <a:ext cx="2933700" cy="2200275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425" y="1"/>
            <a:ext cx="2933700" cy="2200275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96460" y="2247901"/>
            <a:ext cx="2933700" cy="2200275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1800" y="2209801"/>
            <a:ext cx="2933700" cy="2200275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425" y="2209801"/>
            <a:ext cx="2933700" cy="220027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96460" y="4457701"/>
            <a:ext cx="2933700" cy="2200275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1800" y="4457701"/>
            <a:ext cx="2933700" cy="2200275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425" y="4457701"/>
            <a:ext cx="2933700" cy="2200275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0" y="6272292"/>
            <a:ext cx="82266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n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-76200" y="3059668"/>
            <a:ext cx="394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518315" y="6520935"/>
            <a:ext cx="394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97167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880" y="1150756"/>
            <a:ext cx="2933700" cy="220027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9742" y="1143836"/>
            <a:ext cx="2933700" cy="220027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9742" y="3577756"/>
            <a:ext cx="2933700" cy="220027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3442" y="1143837"/>
            <a:ext cx="2933700" cy="220027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3442" y="3577757"/>
            <a:ext cx="2933700" cy="2200275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0" y="6272292"/>
            <a:ext cx="82266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o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-76200" y="3059668"/>
            <a:ext cx="394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262942" y="5680855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992700" y="1072787"/>
            <a:ext cx="13965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A07 NY1050 0101</a:t>
            </a:r>
            <a:endParaRPr lang="en-US" sz="1200" b="1" dirty="0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416" y="3569637"/>
            <a:ext cx="2933700" cy="2200275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1112148" y="3474117"/>
            <a:ext cx="122257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A07 PA10 0101</a:t>
            </a:r>
            <a:endParaRPr lang="en-US" sz="12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3777088" y="3469995"/>
            <a:ext cx="122257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A07 PA10 0401</a:t>
            </a:r>
            <a:endParaRPr lang="en-US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6713874" y="3490587"/>
            <a:ext cx="122257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A07 PA10 1001</a:t>
            </a:r>
            <a:endParaRPr lang="en-US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3682346" y="1052189"/>
            <a:ext cx="13965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A07 NY1050 0401</a:t>
            </a:r>
            <a:endParaRPr lang="en-US" sz="12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6594424" y="1048067"/>
            <a:ext cx="13965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A07 NY1050 1001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38272372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121" y="2922402"/>
            <a:ext cx="2933700" cy="220027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7866" y="632060"/>
            <a:ext cx="2933700" cy="220027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8700" y="630348"/>
            <a:ext cx="2933700" cy="220027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8700" y="2928928"/>
            <a:ext cx="2933700" cy="220027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6272292"/>
            <a:ext cx="82266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p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707670" y="2751920"/>
            <a:ext cx="394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716023" y="5229220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596703" y="630348"/>
            <a:ext cx="13965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A07 NY1050 0103</a:t>
            </a:r>
            <a:endParaRPr lang="en-US" sz="12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726392" y="2783902"/>
            <a:ext cx="122257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A07 PA10 0103</a:t>
            </a:r>
            <a:endParaRPr lang="en-US" sz="12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5623025" y="581557"/>
            <a:ext cx="13965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A07 NY1050 1502</a:t>
            </a:r>
            <a:endParaRPr lang="en-US" sz="12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5734235" y="2809887"/>
            <a:ext cx="122257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A07 PA10 1502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1300107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40" y="0"/>
            <a:ext cx="4023360" cy="2514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40" y="2133600"/>
            <a:ext cx="4023360" cy="2514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40" y="4267200"/>
            <a:ext cx="4023360" cy="2514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0"/>
            <a:ext cx="4023360" cy="2514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2133600"/>
            <a:ext cx="4023360" cy="2514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4267200"/>
            <a:ext cx="4023360" cy="2514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4572000" y="0"/>
            <a:ext cx="838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C 010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572000" y="2133600"/>
            <a:ext cx="838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C 040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572000" y="4264223"/>
            <a:ext cx="838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C 100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0" y="0"/>
            <a:ext cx="857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010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0" y="2133600"/>
            <a:ext cx="857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040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0" y="4264223"/>
            <a:ext cx="857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100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990600" y="6248400"/>
            <a:ext cx="2057400" cy="0"/>
          </a:xfrm>
          <a:prstGeom prst="straightConnector1">
            <a:avLst/>
          </a:prstGeom>
          <a:ln>
            <a:solidFill>
              <a:srgbClr val="0000FF"/>
            </a:solidFill>
            <a:miter lim="800000"/>
            <a:tail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990600" y="60476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sz="1200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Straight Arrow Connector 20"/>
          <p:cNvCxnSpPr/>
          <p:nvPr/>
        </p:nvCxnSpPr>
        <p:spPr>
          <a:xfrm>
            <a:off x="3124200" y="6324600"/>
            <a:ext cx="1371600" cy="0"/>
          </a:xfrm>
          <a:prstGeom prst="straightConnector1">
            <a:avLst/>
          </a:prstGeom>
          <a:ln>
            <a:solidFill>
              <a:srgbClr val="0000FF"/>
            </a:solidFill>
            <a:miter lim="800000"/>
            <a:tail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3057526" y="6123801"/>
            <a:ext cx="4748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1</a:t>
            </a:r>
            <a:endParaRPr lang="en-US" sz="1200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Straight Arrow Connector 23"/>
          <p:cNvCxnSpPr/>
          <p:nvPr/>
        </p:nvCxnSpPr>
        <p:spPr>
          <a:xfrm>
            <a:off x="5029200" y="6248400"/>
            <a:ext cx="1828800" cy="0"/>
          </a:xfrm>
          <a:prstGeom prst="straightConnector1">
            <a:avLst/>
          </a:prstGeom>
          <a:ln>
            <a:solidFill>
              <a:srgbClr val="0000FF"/>
            </a:solidFill>
            <a:miter lim="800000"/>
            <a:tail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5029200" y="60476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sz="1200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Straight Arrow Connector 25"/>
          <p:cNvCxnSpPr/>
          <p:nvPr/>
        </p:nvCxnSpPr>
        <p:spPr>
          <a:xfrm>
            <a:off x="6934200" y="6324600"/>
            <a:ext cx="1447800" cy="0"/>
          </a:xfrm>
          <a:prstGeom prst="straightConnector1">
            <a:avLst/>
          </a:prstGeom>
          <a:ln>
            <a:solidFill>
              <a:srgbClr val="0000FF"/>
            </a:solidFill>
            <a:miter lim="800000"/>
            <a:tail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7096126" y="612380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200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Straight Arrow Connector 29"/>
          <p:cNvCxnSpPr/>
          <p:nvPr/>
        </p:nvCxnSpPr>
        <p:spPr>
          <a:xfrm flipH="1">
            <a:off x="3200400" y="3505200"/>
            <a:ext cx="228600" cy="15240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 flipH="1">
            <a:off x="6867526" y="2536479"/>
            <a:ext cx="228600" cy="15240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-1" y="6276203"/>
            <a:ext cx="80021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a</a:t>
            </a:r>
            <a:endParaRPr lang="en-US" sz="4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93151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40" y="0"/>
            <a:ext cx="4023360" cy="2514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40" y="2133600"/>
            <a:ext cx="4023360" cy="2514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40" y="4267200"/>
            <a:ext cx="4023360" cy="2514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0"/>
            <a:ext cx="4023360" cy="2514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2133600"/>
            <a:ext cx="4023360" cy="2514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4267200"/>
            <a:ext cx="4023360" cy="2514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4572000" y="0"/>
            <a:ext cx="838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C 010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572000" y="2133600"/>
            <a:ext cx="838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C 040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572000" y="4264223"/>
            <a:ext cx="838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C 100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0" y="0"/>
            <a:ext cx="857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010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0" y="2133600"/>
            <a:ext cx="857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040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0" y="4264223"/>
            <a:ext cx="857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100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990600" y="6248400"/>
            <a:ext cx="2057400" cy="0"/>
          </a:xfrm>
          <a:prstGeom prst="straightConnector1">
            <a:avLst/>
          </a:prstGeom>
          <a:ln>
            <a:solidFill>
              <a:srgbClr val="0000FF"/>
            </a:solidFill>
            <a:miter lim="800000"/>
            <a:tail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990600" y="60476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sz="1200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3124200" y="6324600"/>
            <a:ext cx="1371600" cy="0"/>
          </a:xfrm>
          <a:prstGeom prst="straightConnector1">
            <a:avLst/>
          </a:prstGeom>
          <a:ln>
            <a:solidFill>
              <a:srgbClr val="0000FF"/>
            </a:solidFill>
            <a:miter lim="800000"/>
            <a:tail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3057526" y="6123801"/>
            <a:ext cx="4748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1</a:t>
            </a:r>
            <a:endParaRPr lang="en-US" sz="1200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Straight Arrow Connector 18"/>
          <p:cNvCxnSpPr/>
          <p:nvPr/>
        </p:nvCxnSpPr>
        <p:spPr>
          <a:xfrm>
            <a:off x="5029200" y="6248400"/>
            <a:ext cx="1828800" cy="0"/>
          </a:xfrm>
          <a:prstGeom prst="straightConnector1">
            <a:avLst/>
          </a:prstGeom>
          <a:ln>
            <a:solidFill>
              <a:srgbClr val="0000FF"/>
            </a:solidFill>
            <a:miter lim="800000"/>
            <a:tail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5029200" y="60476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sz="1200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Straight Arrow Connector 20"/>
          <p:cNvCxnSpPr/>
          <p:nvPr/>
        </p:nvCxnSpPr>
        <p:spPr>
          <a:xfrm>
            <a:off x="6934200" y="6324600"/>
            <a:ext cx="1447800" cy="0"/>
          </a:xfrm>
          <a:prstGeom prst="straightConnector1">
            <a:avLst/>
          </a:prstGeom>
          <a:ln>
            <a:solidFill>
              <a:srgbClr val="0000FF"/>
            </a:solidFill>
            <a:miter lim="800000"/>
            <a:tail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7096126" y="612380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200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Straight Arrow Connector 22"/>
          <p:cNvCxnSpPr/>
          <p:nvPr/>
        </p:nvCxnSpPr>
        <p:spPr>
          <a:xfrm flipH="1">
            <a:off x="3278428" y="3505200"/>
            <a:ext cx="228600" cy="15240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-1" y="6267965"/>
            <a:ext cx="82266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b</a:t>
            </a:r>
            <a:endParaRPr lang="en-US" sz="4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15851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0800" y="0"/>
            <a:ext cx="3901440" cy="2438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0800" y="2209800"/>
            <a:ext cx="3901440" cy="2438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0800" y="4419600"/>
            <a:ext cx="3901440" cy="2438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4" name="TextBox 23"/>
          <p:cNvSpPr txBox="1"/>
          <p:nvPr/>
        </p:nvSpPr>
        <p:spPr>
          <a:xfrm>
            <a:off x="2286000" y="76200"/>
            <a:ext cx="857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010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286000" y="2209800"/>
            <a:ext cx="857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040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286000" y="4340423"/>
            <a:ext cx="857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100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3048000" y="6324600"/>
            <a:ext cx="1371600" cy="0"/>
          </a:xfrm>
          <a:prstGeom prst="straightConnector1">
            <a:avLst/>
          </a:prstGeom>
          <a:ln>
            <a:solidFill>
              <a:srgbClr val="0000FF"/>
            </a:solidFill>
            <a:miter lim="800000"/>
            <a:tail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3048000" y="6123801"/>
            <a:ext cx="9492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NFRII p75</a:t>
            </a:r>
            <a:endParaRPr lang="en-US" sz="1200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4495800" y="6400800"/>
            <a:ext cx="1812471" cy="0"/>
          </a:xfrm>
          <a:prstGeom prst="straightConnector1">
            <a:avLst/>
          </a:prstGeom>
          <a:ln>
            <a:solidFill>
              <a:srgbClr val="0000FF"/>
            </a:solidFill>
            <a:miter lim="800000"/>
            <a:tail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4495800" y="6200001"/>
            <a:ext cx="928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2 + CH3</a:t>
            </a:r>
            <a:endParaRPr lang="en-US" sz="1200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-1" y="6276196"/>
            <a:ext cx="80021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c</a:t>
            </a:r>
            <a:endParaRPr lang="en-US" sz="4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40371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5064" y="3399139"/>
            <a:ext cx="2933700" cy="220027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5407" y="3423558"/>
            <a:ext cx="2933700" cy="220027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427" y="3429001"/>
            <a:ext cx="2933700" cy="220027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85934" y="1012372"/>
            <a:ext cx="2933700" cy="2200275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1800" y="1012372"/>
            <a:ext cx="2933700" cy="2200275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893" y="1028701"/>
            <a:ext cx="2933700" cy="2200275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0" y="6268315"/>
            <a:ext cx="82266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d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-76200" y="3059668"/>
            <a:ext cx="394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262942" y="5680855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15092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3429001"/>
            <a:ext cx="2933700" cy="220027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3429001"/>
            <a:ext cx="2933700" cy="2200275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1028701"/>
            <a:ext cx="2933700" cy="220027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1028701"/>
            <a:ext cx="2933700" cy="2200275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0" y="6275345"/>
            <a:ext cx="80021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e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104900" y="3144323"/>
            <a:ext cx="394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305300" y="5644635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00331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3600" y="3429001"/>
            <a:ext cx="2933700" cy="220027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1800" y="3429001"/>
            <a:ext cx="2933700" cy="220027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429001"/>
            <a:ext cx="2933700" cy="220027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3600" y="1028701"/>
            <a:ext cx="2933700" cy="2200275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1800" y="1028701"/>
            <a:ext cx="2933700" cy="2200275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28701"/>
            <a:ext cx="2933700" cy="2200275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0" y="6268315"/>
            <a:ext cx="75373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f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-76200" y="3059668"/>
            <a:ext cx="394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262942" y="5680855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74660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3429001"/>
            <a:ext cx="2933700" cy="2200275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3429001"/>
            <a:ext cx="2933700" cy="2200275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1028701"/>
            <a:ext cx="2933700" cy="220027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1028701"/>
            <a:ext cx="2933700" cy="2200275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0" y="6268315"/>
            <a:ext cx="82266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g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76940" y="3144323"/>
            <a:ext cx="394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262942" y="5680855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01091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429001"/>
            <a:ext cx="2933700" cy="220027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1800" y="3429001"/>
            <a:ext cx="2933700" cy="220027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3600" y="3429001"/>
            <a:ext cx="2933700" cy="220027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3600" y="1028701"/>
            <a:ext cx="2933700" cy="2200275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1800" y="1028701"/>
            <a:ext cx="2933700" cy="2200275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28701"/>
            <a:ext cx="2933700" cy="2200275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0" y="6268315"/>
            <a:ext cx="82266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h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-76200" y="3059668"/>
            <a:ext cx="394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262942" y="5680855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b="1" i="1" baseline="-25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b="1" i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51290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9</TotalTime>
  <Words>122</Words>
  <Application>Microsoft Office PowerPoint</Application>
  <PresentationFormat>On-screen Show (4:3)</PresentationFormat>
  <Paragraphs>78</Paragraphs>
  <Slides>1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2" baseType="lpstr">
      <vt:lpstr>Arial</vt:lpstr>
      <vt:lpstr>Calibri</vt:lpstr>
      <vt:lpstr>Calibri Light</vt:lpstr>
      <vt:lpstr>Times New Roman</vt:lpstr>
      <vt:lpstr>Office Theme</vt:lpstr>
      <vt:lpstr>Supporting Information S4: a - o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uquesne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orting Information S5</dc:title>
  <dc:creator>Wilson Meng</dc:creator>
  <cp:lastModifiedBy>Wilson Meng</cp:lastModifiedBy>
  <cp:revision>15</cp:revision>
  <cp:lastPrinted>2015-05-15T13:17:27Z</cp:lastPrinted>
  <dcterms:created xsi:type="dcterms:W3CDTF">2015-05-14T18:12:04Z</dcterms:created>
  <dcterms:modified xsi:type="dcterms:W3CDTF">2015-05-15T15:16:45Z</dcterms:modified>
</cp:coreProperties>
</file>